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jpg" ContentType="image/jpeg"/>
  <Default Extension="emf" ContentType="image/x-emf"/>
  <Default Extension="rels" ContentType="application/vnd.openxmlformats-package.relationships+xml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  <p:sldId id="265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3" d="100"/>
          <a:sy n="103" d="100"/>
        </p:scale>
        <p:origin x="-936" y="3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FEDEA-2F35-2245-8AD6-3033351963C5}" type="datetimeFigureOut">
              <a:rPr lang="en-US" smtClean="0"/>
              <a:t>1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EF176-FDE3-C74A-B7F2-941668DBF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420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FEDEA-2F35-2245-8AD6-3033351963C5}" type="datetimeFigureOut">
              <a:rPr lang="en-US" smtClean="0"/>
              <a:t>1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EF176-FDE3-C74A-B7F2-941668DBF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177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FEDEA-2F35-2245-8AD6-3033351963C5}" type="datetimeFigureOut">
              <a:rPr lang="en-US" smtClean="0"/>
              <a:t>1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EF176-FDE3-C74A-B7F2-941668DBF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0383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FEDEA-2F35-2245-8AD6-3033351963C5}" type="datetimeFigureOut">
              <a:rPr lang="en-US" smtClean="0"/>
              <a:t>1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EF176-FDE3-C74A-B7F2-941668DBF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355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FEDEA-2F35-2245-8AD6-3033351963C5}" type="datetimeFigureOut">
              <a:rPr lang="en-US" smtClean="0"/>
              <a:t>1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EF176-FDE3-C74A-B7F2-941668DBF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4705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FEDEA-2F35-2245-8AD6-3033351963C5}" type="datetimeFigureOut">
              <a:rPr lang="en-US" smtClean="0"/>
              <a:t>12/1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EF176-FDE3-C74A-B7F2-941668DBF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833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FEDEA-2F35-2245-8AD6-3033351963C5}" type="datetimeFigureOut">
              <a:rPr lang="en-US" smtClean="0"/>
              <a:t>12/1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EF176-FDE3-C74A-B7F2-941668DBF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5906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FEDEA-2F35-2245-8AD6-3033351963C5}" type="datetimeFigureOut">
              <a:rPr lang="en-US" smtClean="0"/>
              <a:t>12/1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EF176-FDE3-C74A-B7F2-941668DBF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751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FEDEA-2F35-2245-8AD6-3033351963C5}" type="datetimeFigureOut">
              <a:rPr lang="en-US" smtClean="0"/>
              <a:t>12/1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EF176-FDE3-C74A-B7F2-941668DBF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903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FEDEA-2F35-2245-8AD6-3033351963C5}" type="datetimeFigureOut">
              <a:rPr lang="en-US" smtClean="0"/>
              <a:t>12/1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EF176-FDE3-C74A-B7F2-941668DBF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060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FEDEA-2F35-2245-8AD6-3033351963C5}" type="datetimeFigureOut">
              <a:rPr lang="en-US" smtClean="0"/>
              <a:t>12/1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EF176-FDE3-C74A-B7F2-941668DBF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3640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4FEDEA-2F35-2245-8AD6-3033351963C5}" type="datetimeFigureOut">
              <a:rPr lang="en-US" smtClean="0"/>
              <a:t>1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2EF176-FDE3-C74A-B7F2-941668DBF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884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-308249" y="37525"/>
            <a:ext cx="4894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Additional file: Supplementary Figure 1</a:t>
            </a:r>
            <a:endParaRPr lang="en-US" b="1" dirty="0"/>
          </a:p>
        </p:txBody>
      </p:sp>
      <p:grpSp>
        <p:nvGrpSpPr>
          <p:cNvPr id="11" name="Group 10"/>
          <p:cNvGrpSpPr/>
          <p:nvPr/>
        </p:nvGrpSpPr>
        <p:grpSpPr>
          <a:xfrm>
            <a:off x="68208" y="702752"/>
            <a:ext cx="9011851" cy="5960774"/>
            <a:chOff x="68208" y="702752"/>
            <a:chExt cx="9011851" cy="5960774"/>
          </a:xfrm>
        </p:grpSpPr>
        <p:sp>
          <p:nvSpPr>
            <p:cNvPr id="19" name="TextBox 18"/>
            <p:cNvSpPr txBox="1"/>
            <p:nvPr/>
          </p:nvSpPr>
          <p:spPr>
            <a:xfrm>
              <a:off x="5306183" y="707204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B</a:t>
              </a:r>
              <a:endParaRPr lang="en-US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96831" y="4029686"/>
              <a:ext cx="3068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C</a:t>
              </a:r>
              <a:endParaRPr lang="en-US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630102" y="4079002"/>
              <a:ext cx="3301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D</a:t>
              </a:r>
              <a:endParaRPr lang="en-US" b="1" dirty="0"/>
            </a:p>
          </p:txBody>
        </p:sp>
        <p:pic>
          <p:nvPicPr>
            <p:cNvPr id="22" name="Google Shape;55;p13"/>
            <p:cNvPicPr preferRelativeResize="0"/>
            <p:nvPr/>
          </p:nvPicPr>
          <p:blipFill>
            <a:blip r:embed="rId2">
              <a:alphaModFix/>
            </a:blip>
            <a:stretch>
              <a:fillRect/>
            </a:stretch>
          </p:blipFill>
          <p:spPr>
            <a:xfrm>
              <a:off x="5551802" y="1300754"/>
              <a:ext cx="3443877" cy="223766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8208" y="4399018"/>
              <a:ext cx="1850181" cy="2264508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790648" y="4535386"/>
              <a:ext cx="3289411" cy="2002536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965027" y="4540552"/>
              <a:ext cx="3808745" cy="2002536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423864" y="3008812"/>
              <a:ext cx="12700" cy="38100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423864" y="3008812"/>
              <a:ext cx="12700" cy="38100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423864" y="3008812"/>
              <a:ext cx="12700" cy="38100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423864" y="3008812"/>
              <a:ext cx="12700" cy="38100"/>
            </a:xfrm>
            <a:prstGeom prst="rect">
              <a:avLst/>
            </a:prstGeom>
          </p:spPr>
        </p:pic>
        <p:grpSp>
          <p:nvGrpSpPr>
            <p:cNvPr id="9" name="Group 8"/>
            <p:cNvGrpSpPr/>
            <p:nvPr/>
          </p:nvGrpSpPr>
          <p:grpSpPr>
            <a:xfrm>
              <a:off x="715140" y="702752"/>
              <a:ext cx="4559300" cy="2965317"/>
              <a:chOff x="715140" y="702752"/>
              <a:chExt cx="4559300" cy="2965317"/>
            </a:xfrm>
          </p:grpSpPr>
          <p:sp>
            <p:nvSpPr>
              <p:cNvPr id="10" name="TextBox 9"/>
              <p:cNvSpPr txBox="1"/>
              <p:nvPr/>
            </p:nvSpPr>
            <p:spPr>
              <a:xfrm>
                <a:off x="2731635" y="863030"/>
                <a:ext cx="19939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 smtClean="0"/>
                  <a:t>AB317</a:t>
                </a:r>
                <a:endParaRPr lang="en-US" b="1" dirty="0"/>
              </a:p>
            </p:txBody>
          </p:sp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153798" y="2487340"/>
                <a:ext cx="1533525" cy="1168400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740915" y="2499669"/>
                <a:ext cx="1533525" cy="1168400"/>
              </a:xfrm>
              <a:prstGeom prst="rect">
                <a:avLst/>
              </a:prstGeom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771669" y="1562756"/>
                <a:ext cx="1611598" cy="584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 err="1" smtClean="0"/>
                  <a:t>PbPf</a:t>
                </a:r>
                <a:r>
                  <a:rPr lang="en-US" sz="1600" b="1" dirty="0" smtClean="0"/>
                  <a:t> full CSP </a:t>
                </a:r>
              </a:p>
              <a:p>
                <a:pPr algn="ctr"/>
                <a:r>
                  <a:rPr lang="en-US" sz="1600" b="1" dirty="0" smtClean="0"/>
                  <a:t>GFP-Luc</a:t>
                </a:r>
                <a:endParaRPr lang="en-US" sz="1600" b="1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715140" y="2801133"/>
                <a:ext cx="1700442" cy="584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i="1" dirty="0" smtClean="0"/>
                  <a:t>P. </a:t>
                </a:r>
                <a:r>
                  <a:rPr lang="en-US" sz="1600" b="1" i="1" dirty="0"/>
                  <a:t>f</a:t>
                </a:r>
                <a:r>
                  <a:rPr lang="en-US" sz="1600" b="1" i="1" dirty="0" smtClean="0"/>
                  <a:t>alciparum</a:t>
                </a:r>
              </a:p>
              <a:p>
                <a:pPr algn="ctr"/>
                <a:r>
                  <a:rPr lang="en-US" sz="1600" b="1" i="1" dirty="0" smtClean="0"/>
                  <a:t> </a:t>
                </a:r>
                <a:r>
                  <a:rPr lang="en-US" sz="1600" b="1" dirty="0" smtClean="0"/>
                  <a:t>NF54</a:t>
                </a:r>
                <a:endParaRPr lang="en-US" sz="1600" b="1" dirty="0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949253" y="702752"/>
                <a:ext cx="3257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A</a:t>
                </a:r>
                <a:endParaRPr lang="en-US" b="1" dirty="0"/>
              </a:p>
            </p:txBody>
          </p:sp>
          <p:pic>
            <p:nvPicPr>
              <p:cNvPr id="26" name="Picture 25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728198" y="1309692"/>
                <a:ext cx="1533525" cy="1168399"/>
              </a:xfrm>
              <a:prstGeom prst="rect">
                <a:avLst/>
              </a:prstGeom>
            </p:spPr>
          </p:pic>
          <p:pic>
            <p:nvPicPr>
              <p:cNvPr id="31" name="Picture 30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153798" y="1297364"/>
                <a:ext cx="1533525" cy="1168399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31700920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4366517"/>
              </p:ext>
            </p:extLst>
          </p:nvPr>
        </p:nvGraphicFramePr>
        <p:xfrm>
          <a:off x="1003302" y="925017"/>
          <a:ext cx="4318000" cy="259588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952500"/>
                <a:gridCol w="1498600"/>
                <a:gridCol w="876300"/>
                <a:gridCol w="990600"/>
              </a:tblGrid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Parasite Dos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Average luminescenc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TDEV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Variability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u="none" strike="noStrike">
                          <a:effectLst/>
                        </a:rPr>
                        <a:t>2100</a:t>
                      </a:r>
                      <a:endParaRPr lang="cs-CZ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u="none" strike="noStrike">
                          <a:effectLst/>
                        </a:rPr>
                        <a:t>28034000.0</a:t>
                      </a:r>
                      <a:endParaRPr lang="nb-NO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>
                          <a:effectLst/>
                        </a:rPr>
                        <a:t>8013921.0</a:t>
                      </a:r>
                      <a:endParaRPr lang="hr-HR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>
                          <a:effectLst/>
                        </a:rPr>
                        <a:t>28.6</a:t>
                      </a:r>
                      <a:endParaRPr lang="hr-HR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u="none" strike="noStrike">
                          <a:effectLst/>
                        </a:rPr>
                        <a:t>700</a:t>
                      </a:r>
                      <a:endParaRPr lang="is-I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u="none" strike="noStrike">
                          <a:effectLst/>
                        </a:rPr>
                        <a:t>6534200.0</a:t>
                      </a:r>
                      <a:endParaRPr lang="is-I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u="none" strike="noStrike">
                          <a:effectLst/>
                        </a:rPr>
                        <a:t>3407794.5</a:t>
                      </a:r>
                      <a:endParaRPr lang="is-I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>
                          <a:effectLst/>
                        </a:rPr>
                        <a:t>52.2</a:t>
                      </a:r>
                      <a:endParaRPr lang="hr-HR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u="none" strike="noStrike">
                          <a:effectLst/>
                        </a:rPr>
                        <a:t>233</a:t>
                      </a:r>
                      <a:endParaRPr lang="is-I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u="none" strike="noStrike">
                          <a:effectLst/>
                        </a:rPr>
                        <a:t>3106000.0</a:t>
                      </a:r>
                      <a:endParaRPr lang="is-I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u="none" strike="noStrike">
                          <a:effectLst/>
                        </a:rPr>
                        <a:t>1468765.1</a:t>
                      </a:r>
                      <a:endParaRPr lang="fi-FI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u="none" strike="noStrike">
                          <a:effectLst/>
                        </a:rPr>
                        <a:t>47.3</a:t>
                      </a:r>
                      <a:endParaRPr lang="nb-NO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75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u="none" strike="noStrike">
                          <a:effectLst/>
                        </a:rPr>
                        <a:t>587260.0</a:t>
                      </a:r>
                      <a:endParaRPr lang="fi-FI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u="none" strike="noStrike" dirty="0">
                          <a:effectLst/>
                        </a:rPr>
                        <a:t>222795.9</a:t>
                      </a:r>
                      <a:endParaRPr lang="cs-CZ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u="none" strike="noStrike">
                          <a:effectLst/>
                        </a:rPr>
                        <a:t>37.9</a:t>
                      </a:r>
                      <a:endParaRPr lang="nb-NO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u="none" strike="noStrike">
                          <a:effectLst/>
                        </a:rPr>
                        <a:t>25</a:t>
                      </a:r>
                      <a:endParaRPr lang="is-I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>
                          <a:effectLst/>
                        </a:rPr>
                        <a:t>301516.0</a:t>
                      </a:r>
                      <a:endParaRPr lang="hr-HR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u="none" strike="noStrike">
                          <a:effectLst/>
                        </a:rPr>
                        <a:t>205503.1</a:t>
                      </a:r>
                      <a:endParaRPr lang="is-I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>
                          <a:effectLst/>
                        </a:rPr>
                        <a:t>68.2</a:t>
                      </a:r>
                      <a:endParaRPr lang="hr-HR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 dirty="0">
                          <a:effectLst/>
                        </a:rPr>
                        <a:t>75604.0</a:t>
                      </a:r>
                      <a:endParaRPr lang="hr-H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 dirty="0">
                          <a:effectLst/>
                        </a:rPr>
                        <a:t>33322.9</a:t>
                      </a:r>
                      <a:endParaRPr lang="hr-H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 dirty="0">
                          <a:effectLst/>
                        </a:rPr>
                        <a:t>44.1</a:t>
                      </a:r>
                      <a:endParaRPr lang="hr-H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2047298"/>
              </p:ext>
            </p:extLst>
          </p:nvPr>
        </p:nvGraphicFramePr>
        <p:xfrm>
          <a:off x="1015632" y="3970734"/>
          <a:ext cx="3657600" cy="260350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025748"/>
                <a:gridCol w="931271"/>
                <a:gridCol w="823297"/>
                <a:gridCol w="877284"/>
              </a:tblGrid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Parasite Dos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8s RNA Copy number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TDEV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Variability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u="none" strike="noStrike">
                          <a:effectLst/>
                        </a:rPr>
                        <a:t>2100</a:t>
                      </a:r>
                      <a:endParaRPr lang="cs-CZ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 dirty="0">
                          <a:effectLst/>
                        </a:rPr>
                        <a:t>354818.8</a:t>
                      </a:r>
                      <a:endParaRPr lang="hr-H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u="none" strike="noStrike">
                          <a:effectLst/>
                        </a:rPr>
                        <a:t>192610.2</a:t>
                      </a:r>
                      <a:endParaRPr lang="is-I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>
                          <a:effectLst/>
                        </a:rPr>
                        <a:t>54.3</a:t>
                      </a:r>
                      <a:endParaRPr lang="hr-HR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u="none" strike="noStrike" dirty="0">
                          <a:effectLst/>
                        </a:rPr>
                        <a:t>700</a:t>
                      </a:r>
                      <a:endParaRPr lang="is-I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u="none" strike="noStrike">
                          <a:effectLst/>
                        </a:rPr>
                        <a:t>86030.3</a:t>
                      </a:r>
                      <a:endParaRPr lang="nb-NO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u="none" strike="noStrike">
                          <a:effectLst/>
                        </a:rPr>
                        <a:t>57600.2</a:t>
                      </a:r>
                      <a:endParaRPr lang="nb-NO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u="none" strike="noStrike">
                          <a:effectLst/>
                        </a:rPr>
                        <a:t>67.0</a:t>
                      </a:r>
                      <a:endParaRPr lang="nb-NO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u="none" strike="noStrike">
                          <a:effectLst/>
                        </a:rPr>
                        <a:t>233</a:t>
                      </a:r>
                      <a:endParaRPr lang="is-I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>
                          <a:effectLst/>
                        </a:rPr>
                        <a:t>47826.3</a:t>
                      </a:r>
                      <a:endParaRPr lang="hr-HR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u="none" strike="noStrike">
                          <a:effectLst/>
                        </a:rPr>
                        <a:t>24877.9</a:t>
                      </a:r>
                      <a:endParaRPr lang="is-I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 dirty="0">
                          <a:effectLst/>
                        </a:rPr>
                        <a:t>52.0</a:t>
                      </a:r>
                      <a:endParaRPr lang="hr-H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75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u="none" strike="noStrike">
                          <a:effectLst/>
                        </a:rPr>
                        <a:t>11291.5</a:t>
                      </a:r>
                      <a:endParaRPr lang="nb-NO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200" u="none" strike="noStrike">
                          <a:effectLst/>
                        </a:rPr>
                        <a:t>6060.3</a:t>
                      </a:r>
                      <a:endParaRPr lang="pl-PL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>
                          <a:effectLst/>
                        </a:rPr>
                        <a:t>53.7</a:t>
                      </a:r>
                      <a:endParaRPr lang="hr-HR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u="none" strike="noStrike">
                          <a:effectLst/>
                        </a:rPr>
                        <a:t>25</a:t>
                      </a:r>
                      <a:endParaRPr lang="is-I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 dirty="0">
                          <a:effectLst/>
                        </a:rPr>
                        <a:t>6216.1</a:t>
                      </a:r>
                      <a:endParaRPr lang="hr-H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u="none" strike="noStrike">
                          <a:effectLst/>
                        </a:rPr>
                        <a:t>5278.9</a:t>
                      </a:r>
                      <a:endParaRPr lang="is-I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 dirty="0">
                          <a:effectLst/>
                        </a:rPr>
                        <a:t>84.9</a:t>
                      </a:r>
                      <a:endParaRPr lang="hr-H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u="none" strike="noStrike">
                          <a:effectLst/>
                        </a:rPr>
                        <a:t>15.5</a:t>
                      </a:r>
                      <a:endParaRPr lang="nb-NO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 dirty="0">
                          <a:effectLst/>
                        </a:rPr>
                        <a:t>9.7</a:t>
                      </a:r>
                      <a:endParaRPr lang="hr-H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u="none" strike="noStrike" dirty="0">
                          <a:effectLst/>
                        </a:rPr>
                        <a:t>62.2</a:t>
                      </a:r>
                      <a:endParaRPr lang="hr-H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406879" y="296165"/>
            <a:ext cx="2397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Table 1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653473" y="752411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657913" y="3802126"/>
            <a:ext cx="3140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156910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3</TotalTime>
  <Words>89</Words>
  <Application>Microsoft Macintosh PowerPoint</Application>
  <PresentationFormat>On-screen Show (4:3)</PresentationFormat>
  <Paragraphs>69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JHSP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evel Flores Garcia</dc:creator>
  <cp:lastModifiedBy>Yevel Flores Garcia</cp:lastModifiedBy>
  <cp:revision>63</cp:revision>
  <cp:lastPrinted>2019-07-20T18:41:17Z</cp:lastPrinted>
  <dcterms:created xsi:type="dcterms:W3CDTF">2019-07-18T21:59:54Z</dcterms:created>
  <dcterms:modified xsi:type="dcterms:W3CDTF">2019-12-13T22:49:29Z</dcterms:modified>
</cp:coreProperties>
</file>